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BF1F5C2-9417-4404-AE4A-078640A668E4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5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B0190CA-85EC-4A4A-9B72-07F4C557CEA2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4CC18C-E73F-4E3D-AA7D-11453322A73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03B8A8-A4B7-40F8-B062-3EF99E87BC8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90F7F0-6A1F-4933-8FE1-4DF372B97EE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70AF94-2F38-4843-96B2-E0598624040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8A27F6-675E-4B33-A09B-1670E8D2F9E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3EC488-384A-41B0-A502-AB61B005043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4D1C2B-2502-459D-8760-667BECD3190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3B3850-5031-44EF-904C-170D831D1AD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445B03-ABD9-4115-A2FE-89CB3CDEDAA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4E0DEE-A8D5-4402-8B78-8C79522168C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63E274-9545-491D-A8C4-D62E70D6FD3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73CF10-2D00-4FDC-A0DA-5179529FE9E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BA66B2B-D305-49F1-AE10-5CFE1D52157A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2" descr=""/>
          <p:cNvPicPr/>
          <p:nvPr/>
        </p:nvPicPr>
        <p:blipFill>
          <a:blip r:embed="rId1"/>
          <a:stretch/>
        </p:blipFill>
        <p:spPr>
          <a:xfrm>
            <a:off x="658800" y="1703520"/>
            <a:ext cx="8256600" cy="4240080"/>
          </a:xfrm>
          <a:prstGeom prst="rect">
            <a:avLst/>
          </a:prstGeom>
          <a:ln w="0">
            <a:noFill/>
          </a:ln>
        </p:spPr>
      </p:pic>
      <p:sp>
        <p:nvSpPr>
          <p:cNvPr id="49" name=""/>
          <p:cNvSpPr/>
          <p:nvPr/>
        </p:nvSpPr>
        <p:spPr>
          <a:xfrm>
            <a:off x="836640" y="414360"/>
            <a:ext cx="776412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dditional File 10 ESTs match two distinct poplar 3’ UTR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oplar ESTs DNA sequences aligned to the 3’ UTRs of poplar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LKR/SDH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genes 1 and 2. Stop codons are boxed. Poplar genes are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amed from the BAC accession and gene number. Lines separate two similar sequence patterns to aid comparisons. ESTs DV242515,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B907693, and DB899866 have identical sequences to those shown and are not included in the figure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05T03:22:01Z</dcterms:created>
  <dc:creator> </dc:creator>
  <dc:description/>
  <dc:language>en-US</dc:language>
  <cp:lastModifiedBy>Office 2003 Registered User</cp:lastModifiedBy>
  <dcterms:modified xsi:type="dcterms:W3CDTF">2010-05-18T22:48:33Z</dcterms:modified>
  <cp:revision>2</cp:revision>
  <dc:subject/>
  <dc:title>Slide 1</dc:title>
</cp:coreProperties>
</file>